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54" autoAdjust="0"/>
    <p:restoredTop sz="94660"/>
  </p:normalViewPr>
  <p:slideViewPr>
    <p:cSldViewPr snapToGrid="0">
      <p:cViewPr varScale="1">
        <p:scale>
          <a:sx n="72" d="100"/>
          <a:sy n="72" d="100"/>
        </p:scale>
        <p:origin x="8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80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433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66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912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820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888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99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698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21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59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759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3B0A5-57D5-47E0-BC55-00C27EC5B63F}" type="datetimeFigureOut">
              <a:rPr kumimoji="1" lang="ja-JP" altLang="en-US" smtClean="0"/>
              <a:t>2017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BBEC5-40C9-4B33-A538-F1F7542C5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19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369000" y="8413674"/>
            <a:ext cx="6120000" cy="60016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1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 3. 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Q1 mass </a:t>
            </a:r>
            <a:r>
              <a:rPr lang="en-US" altLang="ja-JP" sz="1100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ectra 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reference OO-HpODE-TG isomers. Reference OO-</a:t>
            </a:r>
            <a:r>
              <a:rPr lang="en-US" altLang="ja-JP" sz="11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pODE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TG isomers were dissolved in methanol containing 0.1 </a:t>
            </a:r>
            <a:r>
              <a:rPr lang="en-US" altLang="ja-JP" sz="11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M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odium acetate (1 µM) and infused directly into the MS system at a flow rate of 10 </a:t>
            </a:r>
            <a:r>
              <a:rPr lang="en-US" altLang="ja-JP" sz="11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L</a:t>
            </a:r>
            <a:r>
              <a:rPr lang="en-US" altLang="ja-JP" sz="11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/min.</a:t>
            </a:r>
            <a:endParaRPr lang="ja-JP" altLang="ja-JP" sz="11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19380" y="185569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 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58" y="1510407"/>
            <a:ext cx="6729483" cy="6885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513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2</TotalTime>
  <Words>44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俊治</dc:creator>
  <cp:lastModifiedBy>加藤俊治</cp:lastModifiedBy>
  <cp:revision>33</cp:revision>
  <cp:lastPrinted>2017-07-23T10:57:15Z</cp:lastPrinted>
  <dcterms:created xsi:type="dcterms:W3CDTF">2017-04-21T10:59:42Z</dcterms:created>
  <dcterms:modified xsi:type="dcterms:W3CDTF">2017-08-01T06:49:24Z</dcterms:modified>
</cp:coreProperties>
</file>